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3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86" d="100"/>
          <a:sy n="86" d="100"/>
        </p:scale>
        <p:origin x="120" y="6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591B6E-DD85-76F5-572D-5B283F611A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0F97B54-B01C-F307-92B0-45FE54A302C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0C5D81-BE07-67FC-2412-361DF9F95F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616F01-3548-29AB-F0F8-9A1FDDCF77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36AA3C-E054-AC18-C6A8-97E162B4A0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6502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E470E5-35EB-A23A-2079-BB9871CDAF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6362F4-D07B-1E1F-0961-5B36A78C19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1DB674-5B17-DD21-E71E-1E23E6FCC6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0775AD-5139-1CC2-AEEE-C7274F615B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FB8E08-27DA-4AF6-1F0A-387854ACBB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852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FCE7323-38EA-D133-4522-CAB0A60EF4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B51A9B-4906-BAC8-5169-9C71FC2EB9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CF110F-2C3C-8FC7-F4F8-A43226068B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4BA0F0-1AAC-1D6D-E001-A5A21194D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8FF68D-5A61-9352-0335-87C1A6761C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329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14FF59-D2FC-1A00-53D8-76A301DF1E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05ED88-C146-71E4-D52B-8A82D42D17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1300F5-F703-297B-FF23-5DC3EE62AA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C5522F-2E8A-C27A-513D-EF13B12F34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E3E46C-71B7-3B86-1E1F-BF18FC584C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0417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67590A-469A-54E1-15FE-C4DB0324F4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44BB84-F999-7B0C-2227-43FAD38FF3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EFFED6-3544-5224-8696-91BA07BBB3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1C4F66-8158-9CBB-61FA-EB7B13DC40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998BF8-2F7C-E9EE-6DF9-2EF54F1E9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012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3A97D0-45D6-CD76-511D-A234E84807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0BC010-D56B-1D68-89FA-062F874BA8A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27F600-0533-19EE-47B9-C4BA6369C7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2539F1-605E-EE35-73DD-09D18ED8AA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119D70-99CF-51DB-CE9D-9C8C7E5646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DA7AC8-40BF-3057-C590-18BE2C4128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087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213718-4BA8-D322-FF13-98AA9A9E54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535FE9-5C4B-17D7-BB59-A961C5EE7F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6250D9-6D6A-E6E5-471C-8002643ECC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943EF32-884B-EF2E-0979-42C0118DCE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7354C19-30FA-41EB-3C5C-6E4EED48544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B429C22-7D79-733B-9F9F-4EFE47ABF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661135C-861B-AED4-E692-8020D4785C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BFCED44-FC99-C913-0FA5-85F87B8B5A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770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6654DB-71D3-C547-4BA8-E0F93B3AEB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DDD4700-575A-9FB4-51DF-AFADC4602C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F4AFD67-5E06-90F9-5329-47574129B6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DBEF4F3-6800-CE73-182B-2858396C34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143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E581F51-4A85-AF76-7BC1-DE09A2DB2B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9EE7159-7E52-C584-D711-53A768BDD4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5CD1CC9-67EB-96A5-E90C-762130DFEE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007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D631AF-32FB-F978-CD96-50E0B0E041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B1ED3B-01F5-CC44-95B6-1A15E1BC4CC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5EE9F9-6317-FC5F-538C-3ADF09AA73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8B52E2-379D-08BB-4BD0-66F920E03D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14F40B-2543-765E-DC0B-F82B19D46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22EB29-FC5F-C9FD-F09E-97A2D04FDE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168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874128-E041-D9EA-D695-63D135E571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BFCE3E4-9E9A-02F4-7967-ACFB507F9EF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12CA2C-E588-0949-E3D4-B06EC90D33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2FB69B-B3DA-0F22-B4F0-0976230EC2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BE11B9-7675-7A9A-A892-97CA47F4E1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2ADA8A-C690-6BC5-238F-81BF6D77D4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8729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A288017-75BD-C380-5C1F-6C0260E0AE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44FACF-2A33-D139-4804-40BB926BD7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5004FB-6988-09C4-218D-923AC21E20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9BBA40-421C-259A-884B-22367F06A1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740E4E-11A4-F140-7277-1E982CA26F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3649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4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Picture 62">
            <a:extLst>
              <a:ext uri="{FF2B5EF4-FFF2-40B4-BE49-F238E27FC236}">
                <a16:creationId xmlns:a16="http://schemas.microsoft.com/office/drawing/2014/main" id="{B437D179-EC79-A18A-FFDB-4FB7DD6B077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96968" y="5689805"/>
            <a:ext cx="2342722" cy="872040"/>
          </a:xfrm>
          <a:prstGeom prst="rect">
            <a:avLst/>
          </a:prstGeom>
        </p:spPr>
      </p:pic>
      <p:sp>
        <p:nvSpPr>
          <p:cNvPr id="64" name="Rectangle 63">
            <a:extLst>
              <a:ext uri="{FF2B5EF4-FFF2-40B4-BE49-F238E27FC236}">
                <a16:creationId xmlns:a16="http://schemas.microsoft.com/office/drawing/2014/main" id="{73E6DE39-2BF0-16CA-2440-A17AB0475033}"/>
              </a:ext>
            </a:extLst>
          </p:cNvPr>
          <p:cNvSpPr/>
          <p:nvPr/>
        </p:nvSpPr>
        <p:spPr>
          <a:xfrm>
            <a:off x="3820366" y="5939180"/>
            <a:ext cx="1467716" cy="25556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5" name="Picture 64">
            <a:extLst>
              <a:ext uri="{FF2B5EF4-FFF2-40B4-BE49-F238E27FC236}">
                <a16:creationId xmlns:a16="http://schemas.microsoft.com/office/drawing/2014/main" id="{2B426979-D73C-2F6D-0B6E-B71C419BDB7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72268" y="249862"/>
            <a:ext cx="1802737" cy="630083"/>
          </a:xfrm>
          <a:prstGeom prst="rect">
            <a:avLst/>
          </a:prstGeom>
        </p:spPr>
      </p:pic>
      <p:sp>
        <p:nvSpPr>
          <p:cNvPr id="66" name="Rectangle 65">
            <a:extLst>
              <a:ext uri="{FF2B5EF4-FFF2-40B4-BE49-F238E27FC236}">
                <a16:creationId xmlns:a16="http://schemas.microsoft.com/office/drawing/2014/main" id="{744F4822-FFC0-7578-FBC2-D51AF4459262}"/>
              </a:ext>
            </a:extLst>
          </p:cNvPr>
          <p:cNvSpPr/>
          <p:nvPr/>
        </p:nvSpPr>
        <p:spPr>
          <a:xfrm>
            <a:off x="3096968" y="5945371"/>
            <a:ext cx="2530066" cy="67675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0365557D-1E62-0D11-D4DE-C10E73B6742D}"/>
              </a:ext>
            </a:extLst>
          </p:cNvPr>
          <p:cNvSpPr/>
          <p:nvPr/>
        </p:nvSpPr>
        <p:spPr>
          <a:xfrm>
            <a:off x="3829154" y="5945372"/>
            <a:ext cx="1467716" cy="25556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631E8F42-4382-008A-E7EC-22D7919E2EDE}"/>
              </a:ext>
            </a:extLst>
          </p:cNvPr>
          <p:cNvSpPr txBox="1"/>
          <p:nvPr/>
        </p:nvSpPr>
        <p:spPr>
          <a:xfrm rot="5400000">
            <a:off x="3507981" y="6079256"/>
            <a:ext cx="7008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E180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F969758E-967C-C23B-5829-EB52E5D72324}"/>
              </a:ext>
            </a:extLst>
          </p:cNvPr>
          <p:cNvSpPr txBox="1"/>
          <p:nvPr/>
        </p:nvSpPr>
        <p:spPr>
          <a:xfrm rot="5400000">
            <a:off x="3777070" y="6166652"/>
            <a:ext cx="8756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LV con 50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D2E8E2F6-478A-76BB-6315-7B2C512708EA}"/>
              </a:ext>
            </a:extLst>
          </p:cNvPr>
          <p:cNvSpPr txBox="1"/>
          <p:nvPr/>
        </p:nvSpPr>
        <p:spPr>
          <a:xfrm rot="5400000">
            <a:off x="4204976" y="6096889"/>
            <a:ext cx="7360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4.15.1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EE3B05BF-7CC4-75B7-A1CC-CF25DC0D2A44}"/>
              </a:ext>
            </a:extLst>
          </p:cNvPr>
          <p:cNvSpPr txBox="1"/>
          <p:nvPr/>
        </p:nvSpPr>
        <p:spPr>
          <a:xfrm rot="5400000">
            <a:off x="4455005" y="6166653"/>
            <a:ext cx="9460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LV GAN 50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FCF47C32-0579-C330-436D-E7C21C16A79D}"/>
              </a:ext>
            </a:extLst>
          </p:cNvPr>
          <p:cNvSpPr txBox="1"/>
          <p:nvPr/>
        </p:nvSpPr>
        <p:spPr>
          <a:xfrm rot="5400000">
            <a:off x="4961548" y="6050306"/>
            <a:ext cx="6429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/>
              <a:t>Anova</a:t>
            </a:r>
            <a:endParaRPr lang="en-US" sz="1400" dirty="0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9865B5C0-2EC2-B60A-2453-4E14016298DA}"/>
              </a:ext>
            </a:extLst>
          </p:cNvPr>
          <p:cNvSpPr txBox="1"/>
          <p:nvPr/>
        </p:nvSpPr>
        <p:spPr>
          <a:xfrm>
            <a:off x="94073" y="2986984"/>
            <a:ext cx="2569550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13.</a:t>
            </a:r>
          </a:p>
          <a:p>
            <a:r>
              <a:rPr lang="en-US" dirty="0"/>
              <a:t>Differential expression in </a:t>
            </a:r>
          </a:p>
          <a:p>
            <a:r>
              <a:rPr lang="en-US" dirty="0"/>
              <a:t>ME180 and GAN edited </a:t>
            </a:r>
          </a:p>
          <a:p>
            <a:r>
              <a:rPr lang="en-US" dirty="0"/>
              <a:t>cell lines.</a:t>
            </a:r>
          </a:p>
        </p:txBody>
      </p:sp>
      <p:pic>
        <p:nvPicPr>
          <p:cNvPr id="74" name="Picture 73">
            <a:extLst>
              <a:ext uri="{FF2B5EF4-FFF2-40B4-BE49-F238E27FC236}">
                <a16:creationId xmlns:a16="http://schemas.microsoft.com/office/drawing/2014/main" id="{C39EF907-BD26-0160-7B92-9510EC2BF90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56821" y="1357209"/>
            <a:ext cx="3973859" cy="5285232"/>
          </a:xfrm>
          <a:prstGeom prst="rect">
            <a:avLst/>
          </a:prstGeom>
        </p:spPr>
      </p:pic>
      <p:pic>
        <p:nvPicPr>
          <p:cNvPr id="75" name="Picture 74">
            <a:extLst>
              <a:ext uri="{FF2B5EF4-FFF2-40B4-BE49-F238E27FC236}">
                <a16:creationId xmlns:a16="http://schemas.microsoft.com/office/drawing/2014/main" id="{3260B763-A2CD-8922-9755-E6B4E48679E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88057" y="1344884"/>
            <a:ext cx="3961955" cy="5297557"/>
          </a:xfrm>
          <a:prstGeom prst="rect">
            <a:avLst/>
          </a:prstGeom>
        </p:spPr>
      </p:pic>
      <p:sp>
        <p:nvSpPr>
          <p:cNvPr id="76" name="TextBox 75">
            <a:extLst>
              <a:ext uri="{FF2B5EF4-FFF2-40B4-BE49-F238E27FC236}">
                <a16:creationId xmlns:a16="http://schemas.microsoft.com/office/drawing/2014/main" id="{30EE24BA-DE22-A7D7-039E-DF2D4C9C6414}"/>
              </a:ext>
            </a:extLst>
          </p:cNvPr>
          <p:cNvSpPr txBox="1"/>
          <p:nvPr/>
        </p:nvSpPr>
        <p:spPr>
          <a:xfrm>
            <a:off x="4465272" y="551539"/>
            <a:ext cx="461665" cy="8056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dirty="0"/>
              <a:t>ME 180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D3DDFC43-B7A0-10D4-EB01-0C4BB17BE84B}"/>
              </a:ext>
            </a:extLst>
          </p:cNvPr>
          <p:cNvSpPr txBox="1"/>
          <p:nvPr/>
        </p:nvSpPr>
        <p:spPr>
          <a:xfrm>
            <a:off x="5378677" y="449446"/>
            <a:ext cx="738664" cy="895438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dirty="0"/>
              <a:t>ME 180/</a:t>
            </a:r>
          </a:p>
          <a:p>
            <a:r>
              <a:rPr lang="en-US" dirty="0"/>
              <a:t> C4.15.1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0B2E4411-0C10-CCE0-377C-D10ADF031390}"/>
              </a:ext>
            </a:extLst>
          </p:cNvPr>
          <p:cNvSpPr txBox="1"/>
          <p:nvPr/>
        </p:nvSpPr>
        <p:spPr>
          <a:xfrm>
            <a:off x="4849040" y="270152"/>
            <a:ext cx="738664" cy="108677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dirty="0"/>
              <a:t> C4.15.1/</a:t>
            </a:r>
          </a:p>
          <a:p>
            <a:r>
              <a:rPr lang="en-US" dirty="0" err="1"/>
              <a:t>Cont</a:t>
            </a:r>
            <a:r>
              <a:rPr lang="en-US" dirty="0"/>
              <a:t> LV 50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93AC70F1-B733-8590-A687-153AD2353601}"/>
              </a:ext>
            </a:extLst>
          </p:cNvPr>
          <p:cNvSpPr txBox="1"/>
          <p:nvPr/>
        </p:nvSpPr>
        <p:spPr>
          <a:xfrm>
            <a:off x="5910830" y="284351"/>
            <a:ext cx="738664" cy="1072858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dirty="0"/>
              <a:t> C4.15.1/</a:t>
            </a:r>
          </a:p>
          <a:p>
            <a:r>
              <a:rPr lang="en-US" dirty="0"/>
              <a:t>GAN LV 50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0C061363-5481-B629-6150-5C3365590837}"/>
              </a:ext>
            </a:extLst>
          </p:cNvPr>
          <p:cNvSpPr txBox="1"/>
          <p:nvPr/>
        </p:nvSpPr>
        <p:spPr>
          <a:xfrm>
            <a:off x="8460903" y="543173"/>
            <a:ext cx="461665" cy="805670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dirty="0"/>
              <a:t>ME 180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08925C6B-4062-C228-C3EE-FBF7DB51DBDA}"/>
              </a:ext>
            </a:extLst>
          </p:cNvPr>
          <p:cNvSpPr txBox="1"/>
          <p:nvPr/>
        </p:nvSpPr>
        <p:spPr>
          <a:xfrm>
            <a:off x="9374246" y="458533"/>
            <a:ext cx="738664" cy="895438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dirty="0"/>
              <a:t>ME 180/</a:t>
            </a:r>
          </a:p>
          <a:p>
            <a:r>
              <a:rPr lang="en-US" dirty="0"/>
              <a:t> C4.15.1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A3A6E676-735E-9E4F-E1ED-6C40E34593F3}"/>
              </a:ext>
            </a:extLst>
          </p:cNvPr>
          <p:cNvSpPr txBox="1"/>
          <p:nvPr/>
        </p:nvSpPr>
        <p:spPr>
          <a:xfrm>
            <a:off x="8844609" y="258112"/>
            <a:ext cx="738664" cy="1086772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dirty="0"/>
              <a:t> C4.15.1/</a:t>
            </a:r>
          </a:p>
          <a:p>
            <a:r>
              <a:rPr lang="en-US" dirty="0" err="1"/>
              <a:t>Cont</a:t>
            </a:r>
            <a:r>
              <a:rPr lang="en-US" dirty="0"/>
              <a:t> LV 50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A824C6F8-D818-F07A-8C3E-07B551E5A197}"/>
              </a:ext>
            </a:extLst>
          </p:cNvPr>
          <p:cNvSpPr txBox="1"/>
          <p:nvPr/>
        </p:nvSpPr>
        <p:spPr>
          <a:xfrm>
            <a:off x="9921886" y="275985"/>
            <a:ext cx="738664" cy="1072858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dirty="0"/>
              <a:t> C4.15.1/</a:t>
            </a:r>
          </a:p>
          <a:p>
            <a:r>
              <a:rPr lang="en-US" dirty="0"/>
              <a:t>GAN LV 50</a:t>
            </a:r>
          </a:p>
        </p:txBody>
      </p:sp>
    </p:spTree>
    <p:extLst>
      <p:ext uri="{BB962C8B-B14F-4D97-AF65-F5344CB8AC3E}">
        <p14:creationId xmlns:p14="http://schemas.microsoft.com/office/powerpoint/2010/main" val="18655065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61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rivatsan, Eri S. (he/him/his)</dc:creator>
  <cp:lastModifiedBy>Srivatsan, Eri S. (he/him/his)</cp:lastModifiedBy>
  <cp:revision>12</cp:revision>
  <dcterms:created xsi:type="dcterms:W3CDTF">2024-02-09T21:19:49Z</dcterms:created>
  <dcterms:modified xsi:type="dcterms:W3CDTF">2024-02-09T22:01:17Z</dcterms:modified>
</cp:coreProperties>
</file>